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0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76" autoAdjust="0"/>
    <p:restoredTop sz="92986" autoAdjust="0"/>
  </p:normalViewPr>
  <p:slideViewPr>
    <p:cSldViewPr snapToGrid="0" snapToObjects="1">
      <p:cViewPr>
        <p:scale>
          <a:sx n="95" d="100"/>
          <a:sy n="95" d="100"/>
        </p:scale>
        <p:origin x="2022" y="-1152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263235-826B-4DBE-BF6E-0C185A76ABA3}" type="datetimeFigureOut">
              <a:rPr lang="zh-CN" altLang="en-US" smtClean="0"/>
              <a:pPr/>
              <a:t>2018/8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50AFE5-DE01-4638-B01A-C45FD2F995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438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3132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603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069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942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341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2049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215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972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429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193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569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442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71" t="5222" r="20559" b="6875"/>
          <a:stretch/>
        </p:blipFill>
        <p:spPr>
          <a:xfrm>
            <a:off x="2742236" y="1521600"/>
            <a:ext cx="3290683" cy="4298639"/>
          </a:xfrm>
        </p:spPr>
      </p:pic>
      <p:sp>
        <p:nvSpPr>
          <p:cNvPr id="5" name="文本框 4"/>
          <p:cNvSpPr txBox="1"/>
          <p:nvPr/>
        </p:nvSpPr>
        <p:spPr>
          <a:xfrm>
            <a:off x="874551" y="1520337"/>
            <a:ext cx="202948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UDP-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curonat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carboxyl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946758" y="1732801"/>
            <a:ext cx="10252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a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48225" y="1937854"/>
            <a:ext cx="303991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hylenetetrahydrofolat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ctase (NAD(P)H)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806612" y="2155348"/>
            <a:ext cx="21653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ine 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methyltransferas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232776" y="2361386"/>
            <a:ext cx="169349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malate dehydrogen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03769" y="2566437"/>
            <a:ext cx="283239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at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hydrogenase (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carboxylating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NAD+)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976406" y="2786697"/>
            <a:ext cx="102710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athrin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241437" y="2990517"/>
            <a:ext cx="169349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trahydrofolat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convers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560007" y="3194751"/>
            <a:ext cx="141199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at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356294" y="3407215"/>
            <a:ext cx="169475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hionin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522755" y="3612268"/>
            <a:ext cx="16740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in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273540" y="4453699"/>
            <a:ext cx="165277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bohydrat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35971" y="3822250"/>
            <a:ext cx="236189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tyl-CoA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synthetic process from pyruvate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488428" y="4028618"/>
            <a:ext cx="176144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serine metabol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619098" y="4239767"/>
            <a:ext cx="133806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carboxylic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id cycle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976407" y="4643928"/>
            <a:ext cx="92888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sicl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ck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950453" y="4863804"/>
            <a:ext cx="96471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823219" y="5488544"/>
            <a:ext cx="113395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solic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osome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043115" y="5075882"/>
            <a:ext cx="93259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lamen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200683" y="5278007"/>
            <a:ext cx="177253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a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nent of membrane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954339" y="3314341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process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939499" y="3504070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component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48"/>
          <p:cNvSpPr txBox="1"/>
          <p:nvPr/>
        </p:nvSpPr>
        <p:spPr>
          <a:xfrm>
            <a:off x="5954323" y="3686101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function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305371" y="1543836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3782295" y="1755037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3722965" y="1966238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3608125" y="2184947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3595145" y="2392835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3518641" y="2593312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3508872" y="2801200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4272718" y="3003240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4055622" y="3214092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3692152" y="3432238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3585888" y="3636923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3583411" y="3834564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3529045" y="4047028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3427805" y="4266105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3364357" y="4473957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3365999" y="4669585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3252421" y="4872132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469383" y="5100883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306736" y="5303430"/>
            <a:ext cx="34092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3271725" y="5512988"/>
            <a:ext cx="2297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2852992" y="5732058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26"/>
          <p:cNvSpPr txBox="1"/>
          <p:nvPr/>
        </p:nvSpPr>
        <p:spPr>
          <a:xfrm>
            <a:off x="3461525" y="5723731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26"/>
          <p:cNvSpPr txBox="1"/>
          <p:nvPr/>
        </p:nvSpPr>
        <p:spPr>
          <a:xfrm>
            <a:off x="4080476" y="5734658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26"/>
          <p:cNvSpPr txBox="1"/>
          <p:nvPr/>
        </p:nvSpPr>
        <p:spPr>
          <a:xfrm>
            <a:off x="4685620" y="5722151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48"/>
          <p:cNvSpPr txBox="1"/>
          <p:nvPr/>
        </p:nvSpPr>
        <p:spPr>
          <a:xfrm>
            <a:off x="3633510" y="5886277"/>
            <a:ext cx="1252566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og10(</a:t>
            </a:r>
            <a:r>
              <a:rPr lang="en-US" altLang="zh-CN" sz="132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value</a:t>
            </a:r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26"/>
          <p:cNvSpPr txBox="1"/>
          <p:nvPr/>
        </p:nvSpPr>
        <p:spPr>
          <a:xfrm>
            <a:off x="5302845" y="5727246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48"/>
          <p:cNvSpPr txBox="1"/>
          <p:nvPr/>
        </p:nvSpPr>
        <p:spPr>
          <a:xfrm>
            <a:off x="3063357" y="1281511"/>
            <a:ext cx="2648440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ost enriched GO terms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矩形 55"/>
          <p:cNvSpPr/>
          <p:nvPr/>
        </p:nvSpPr>
        <p:spPr>
          <a:xfrm>
            <a:off x="42402" y="363852"/>
            <a:ext cx="683200" cy="2959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</a:t>
            </a:r>
            <a:r>
              <a:rPr lang="en-US" altLang="zh-CN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S1</a:t>
            </a:r>
            <a:endParaRPr lang="en-US" altLang="zh-CN" sz="1323" b="1" dirty="0">
              <a:latin typeface="Times New Roman" panose="02020603050405020304" pitchFamily="18" charset="0"/>
              <a:ea typeface="Arial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4331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3</TotalTime>
  <Words>107</Words>
  <Application>Microsoft Office PowerPoint</Application>
  <PresentationFormat>自定义</PresentationFormat>
  <Paragraphs>5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yzyangyan</cp:lastModifiedBy>
  <cp:revision>159</cp:revision>
  <dcterms:created xsi:type="dcterms:W3CDTF">2017-02-03T22:12:08Z</dcterms:created>
  <dcterms:modified xsi:type="dcterms:W3CDTF">2018-08-23T04:39:03Z</dcterms:modified>
</cp:coreProperties>
</file>